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94630"/>
  </p:normalViewPr>
  <p:slideViewPr>
    <p:cSldViewPr snapToGrid="0" snapToObjects="1">
      <p:cViewPr varScale="1">
        <p:scale>
          <a:sx n="87" d="100"/>
          <a:sy n="87" d="100"/>
        </p:scale>
        <p:origin x="12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5E5DD7-C011-ED4B-A5D3-A213C7BAED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D21993E-4845-3C48-99B5-12CD50AC46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FC78BE4-F292-BA4B-B8CF-DCA2723B2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E3DB0CC-591B-5141-873D-8E0D95D9B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0DA1826-EF61-FE46-AFC8-9A7D6E80D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89319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D443DD9-DF8A-4A46-810E-4172DD2A9E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CB0F67E2-7554-7947-ABEA-7525607939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AA4B59B-DB04-AA41-836D-2CA8F86F4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4BD00980-BC67-014B-B3CD-1F17F7441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99E76578-F2C5-5544-80E7-471E22FD1C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30888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00A9CBC-79F3-1149-9EFD-DF8D2FEFA8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1F2A73B-1AF4-E04E-9CDF-2A0329CDBC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4968931-1301-7946-9D95-CD069C5E3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5B957C35-133D-FB4C-A9E7-1BF2EE025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E2335AD-F60D-F14F-9C41-6CB57A605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0672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45C7B1B-3C5C-004B-83D1-684697571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0ECCB49C-9668-4C49-9DAF-0EECEC09DE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DE91059-80A1-6244-954A-D13C23CF2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4C2110F-9CB2-904A-A7BD-005BC215E1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866EAB7-B2FD-F24F-B73E-D90ECEC39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43775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BFE9ED-D9F3-8144-922A-6AB3A32970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88F81EFD-B8BF-934D-A81F-49CF08E606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D4D18D1-2622-5641-9565-F1F223E99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EA33270-FE01-8542-ADD7-279DEC57B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D5FCBF1-E187-7B4D-8B3A-80772A1F6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96426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6A80EEA-C09D-424E-AD1A-4356250A9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F3054D6-457D-334D-8A79-BE526D2840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570F7C8C-B3C5-4A44-BDE1-A6057873C6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EC4D944D-900A-6E49-90A3-E5CB0A694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BCCA5FCC-BEE2-6245-A133-4A2C57CF4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B99C04E7-EE3D-A844-9CD1-B8F780EA95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62548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FD11566-E38E-1A40-8074-02C45DC14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4F3C34E-111B-EF48-A8EA-6E1A8292A6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8FBC86F-C6D8-B742-9939-497B0DE0D9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DC869EE9-7D0A-4842-A85B-C8C1BD144E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76AD19B2-67FC-DC47-B215-87A346BAB3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D104DC1F-8864-8F4B-B4AD-BFD5B6E70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0B1868FB-7667-9F44-A7E5-CF24991DC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98AEE66F-F1DA-8D4F-BE16-2E80AFB61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9238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A3F8E9A-25E6-F748-9BF3-081671773B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65AB61AB-A0B2-6040-B23C-005D53FC2F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20755B8D-6FF7-8242-98C3-F44537C64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1799E911-F613-4548-B9A1-982E4079B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47094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695193DB-5A24-D54E-BA22-AB837EA41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7C9B7874-EBDF-5B43-985E-B4C9174EA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1A0C092A-9A33-3344-88F6-1536F6F41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38387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048E6E-ACDF-7444-82EA-FEF21007E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D75EC3E2-3DBE-C94E-9566-8093592CCE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6095796-AEB8-3446-96FD-6C574570F4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2396D1F7-A670-164C-83E2-5162DC3D5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DDDAD94E-12F7-9A41-A47C-21F3A7324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09874F1D-94F7-CB40-A8AE-BC4E03F04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1756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1596C1F-15D8-2B4E-A083-4868492354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1648A344-58D6-464B-B82A-2B1FF6F541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C8670E40-E031-2249-AF9C-1F894BB7C7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FA2FC79D-17A1-7949-AD84-E9D64B84E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205FF21-F684-2F4C-B8F3-C2FBD8925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A7D4F20-323A-564C-AFD4-5AF53E63C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08629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8F66F7DA-352A-304E-9165-2562100450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084CD2B-2832-0846-BAA9-B7234DD77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57E80C7D-833E-B442-9E13-F8D5B73D45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22E150-BE60-D344-98A3-CC2816FF209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16E5F44-3FF3-D04C-A25F-B702CDB28F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1EA1D05-DFAC-C548-931A-7F0D651537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6841F-A9A5-2B48-ADB9-8B0EC5AF04B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09646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C7D6C804-2769-894C-9F87-C09CD954B4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7625341"/>
              </p:ext>
            </p:extLst>
          </p:nvPr>
        </p:nvGraphicFramePr>
        <p:xfrm>
          <a:off x="1209368" y="1666568"/>
          <a:ext cx="8996516" cy="4444626"/>
        </p:xfrm>
        <a:graphic>
          <a:graphicData uri="http://schemas.openxmlformats.org/drawingml/2006/table">
            <a:tbl>
              <a:tblPr firstRow="1" firstCol="1" bandRow="1"/>
              <a:tblGrid>
                <a:gridCol w="2420315">
                  <a:extLst>
                    <a:ext uri="{9D8B030D-6E8A-4147-A177-3AD203B41FA5}">
                      <a16:colId xmlns:a16="http://schemas.microsoft.com/office/drawing/2014/main" val="3728485538"/>
                    </a:ext>
                  </a:extLst>
                </a:gridCol>
                <a:gridCol w="2573603">
                  <a:extLst>
                    <a:ext uri="{9D8B030D-6E8A-4147-A177-3AD203B41FA5}">
                      <a16:colId xmlns:a16="http://schemas.microsoft.com/office/drawing/2014/main" val="1971603574"/>
                    </a:ext>
                  </a:extLst>
                </a:gridCol>
                <a:gridCol w="2573603">
                  <a:extLst>
                    <a:ext uri="{9D8B030D-6E8A-4147-A177-3AD203B41FA5}">
                      <a16:colId xmlns:a16="http://schemas.microsoft.com/office/drawing/2014/main" val="1586651548"/>
                    </a:ext>
                  </a:extLst>
                </a:gridCol>
                <a:gridCol w="1428995">
                  <a:extLst>
                    <a:ext uri="{9D8B030D-6E8A-4147-A177-3AD203B41FA5}">
                      <a16:colId xmlns:a16="http://schemas.microsoft.com/office/drawing/2014/main" val="564153464"/>
                    </a:ext>
                  </a:extLst>
                </a:gridCol>
              </a:tblGrid>
              <a:tr h="958645">
                <a:tc gridSpan="4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3 Table. Comparison of the relationship of platelet marker levels to platelet count in patients and controls.</a:t>
                      </a:r>
                      <a:endParaRPr lang="pt-BR" sz="14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08048250"/>
                  </a:ext>
                </a:extLst>
              </a:tr>
              <a:tr h="568483">
                <a:tc row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 (pg/mL) /Platelet (x10³/µL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ntrols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tients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8064384"/>
                  </a:ext>
                </a:extLst>
              </a:tr>
              <a:tr h="643566">
                <a:tc v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dian [IQ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 vMerge="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5090420"/>
                  </a:ext>
                </a:extLst>
              </a:tr>
              <a:tr h="568483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XCL4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6 [2.8-4.1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7.0 [8.7-30.5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8458656"/>
                  </a:ext>
                </a:extLst>
              </a:tr>
              <a:tr h="568483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D40L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 [1.7-2.9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.0 [6.8-26.9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3347121"/>
                  </a:ext>
                </a:extLst>
              </a:tr>
              <a:tr h="568483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 err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selectin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3.8 [54.7-89.8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2 [162-387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413614"/>
                  </a:ext>
                </a:extLst>
              </a:tr>
              <a:tr h="568483">
                <a:tc gridSpan="4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oups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re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red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Mann-Whitney test. IQ: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rquartile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range .</a:t>
                      </a:r>
                    </a:p>
                  </a:txBody>
                  <a:tcPr marL="68580" marR="68580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9525" marB="0" anchor="ctr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8837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605282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83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5</cp:revision>
  <dcterms:created xsi:type="dcterms:W3CDTF">2020-03-26T12:26:19Z</dcterms:created>
  <dcterms:modified xsi:type="dcterms:W3CDTF">2020-06-23T21:29:02Z</dcterms:modified>
</cp:coreProperties>
</file>